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  <p:sldMasterId id="2147483648" r:id="rId5"/>
  </p:sldMasterIdLst>
  <p:sldIdLst>
    <p:sldId id="258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433229-312E-20F0-D201-2924EE22C733}" v="31" dt="2023-05-08T13:08:28.588"/>
    <p1510:client id="{4C74D3DA-5EFC-427C-96FC-D947E5695070}" v="16" dt="2022-06-17T08:27:17.734"/>
    <p1510:client id="{5D18BF64-A140-13D9-600A-1E5C299A36E4}" v="2" dt="2022-07-25T23:53:12.056"/>
    <p1510:client id="{865F4B41-67EC-CAED-8862-3E5426A5A7BA}" v="245" dt="2022-12-02T05:35:40.841"/>
    <p1510:client id="{88076702-A3C5-56E5-ED76-6CD22C87E19D}" v="132" dt="2023-04-05T03:54:48.583"/>
    <p1510:client id="{A9DFF6A4-9388-6AA4-48DB-71A0FFD98DB2}" v="203" dt="2022-10-27T23:25:38.769"/>
    <p1510:client id="{B514FC15-A2B0-975F-3227-8DD897A5AECF}" v="15" dt="2022-07-26T03:40:00.724"/>
    <p1510:client id="{BE0A897C-FD4D-F0DA-7D8C-AD07EA7D8F44}" v="55" dt="2022-07-29T03:03:00.857"/>
    <p1510:client id="{C52A1873-C7D1-D577-1FF5-C5DD69177EB9}" v="100" dt="2022-10-21T22:59:51.558"/>
    <p1510:client id="{E9FBED84-977E-2948-871D-3C0648642F75}" v="451" dt="2022-10-28T00:01:04.859"/>
    <p1510:client id="{ED0FAD01-9A29-0335-7D1B-97569D4470EB}" v="22" dt="2023-04-05T03:41:13.079"/>
    <p1510:client id="{F5C143F0-CA58-1917-CA61-E3A6DECEBBE8}" v="5" dt="2023-04-05T03:44:43.825"/>
    <p1510:client id="{F98BF479-A884-6AEF-8417-F986890E20EB}" v="102" dt="2022-08-03T01:19:02.1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2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2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2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nya Moore" userId="S::sonya.moore@unimelb.edu.au::d4cb55d6-0971-4265-b578-07a12dd66407" providerId="AD" clId="Web-{865F4B41-67EC-CAED-8862-3E5426A5A7BA}"/>
    <pc:docChg chg="modSld">
      <pc:chgData name="Sonya Moore" userId="S::sonya.moore@unimelb.edu.au::d4cb55d6-0971-4265-b578-07a12dd66407" providerId="AD" clId="Web-{865F4B41-67EC-CAED-8862-3E5426A5A7BA}" dt="2022-12-02T05:35:40.841" v="147" actId="14100"/>
      <pc:docMkLst>
        <pc:docMk/>
      </pc:docMkLst>
      <pc:sldChg chg="modSp">
        <pc:chgData name="Sonya Moore" userId="S::sonya.moore@unimelb.edu.au::d4cb55d6-0971-4265-b578-07a12dd66407" providerId="AD" clId="Web-{865F4B41-67EC-CAED-8862-3E5426A5A7BA}" dt="2022-12-02T05:27:08.481" v="70"/>
        <pc:sldMkLst>
          <pc:docMk/>
          <pc:sldMk cId="3073807009" sldId="257"/>
        </pc:sldMkLst>
        <pc:graphicFrameChg chg="mod modGraphic">
          <ac:chgData name="Sonya Moore" userId="S::sonya.moore@unimelb.edu.au::d4cb55d6-0971-4265-b578-07a12dd66407" providerId="AD" clId="Web-{865F4B41-67EC-CAED-8862-3E5426A5A7BA}" dt="2022-12-02T05:26:01.089" v="34"/>
          <ac:graphicFrameMkLst>
            <pc:docMk/>
            <pc:sldMk cId="3073807009" sldId="257"/>
            <ac:graphicFrameMk id="13" creationId="{E6DCDEED-A15C-8956-2D72-5C15B14969F2}"/>
          </ac:graphicFrameMkLst>
        </pc:graphicFrameChg>
        <pc:graphicFrameChg chg="mod modGraphic">
          <ac:chgData name="Sonya Moore" userId="S::sonya.moore@unimelb.edu.au::d4cb55d6-0971-4265-b578-07a12dd66407" providerId="AD" clId="Web-{865F4B41-67EC-CAED-8862-3E5426A5A7BA}" dt="2022-12-02T05:27:08.481" v="70"/>
          <ac:graphicFrameMkLst>
            <pc:docMk/>
            <pc:sldMk cId="3073807009" sldId="257"/>
            <ac:graphicFrameMk id="17" creationId="{C8377B3A-0B52-2DD3-83D8-9BF443349E95}"/>
          </ac:graphicFrameMkLst>
        </pc:graphicFrameChg>
      </pc:sldChg>
      <pc:sldChg chg="modSp">
        <pc:chgData name="Sonya Moore" userId="S::sonya.moore@unimelb.edu.au::d4cb55d6-0971-4265-b578-07a12dd66407" providerId="AD" clId="Web-{865F4B41-67EC-CAED-8862-3E5426A5A7BA}" dt="2022-12-02T05:35:40.841" v="147" actId="14100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865F4B41-67EC-CAED-8862-3E5426A5A7BA}" dt="2022-12-02T05:30:09.253" v="116" actId="20577"/>
          <ac:spMkLst>
            <pc:docMk/>
            <pc:sldMk cId="2581054229" sldId="259"/>
            <ac:spMk id="4" creationId="{17618A50-63C7-FFE2-3833-36B56C2C9543}"/>
          </ac:spMkLst>
        </pc:spChg>
        <pc:spChg chg="mod">
          <ac:chgData name="Sonya Moore" userId="S::sonya.moore@unimelb.edu.au::d4cb55d6-0971-4265-b578-07a12dd66407" providerId="AD" clId="Web-{865F4B41-67EC-CAED-8862-3E5426A5A7BA}" dt="2022-12-02T05:32:28.226" v="131" actId="1076"/>
          <ac:spMkLst>
            <pc:docMk/>
            <pc:sldMk cId="2581054229" sldId="259"/>
            <ac:spMk id="6" creationId="{B17B67D0-0909-5416-8EF8-E6015664302F}"/>
          </ac:spMkLst>
        </pc:spChg>
        <pc:spChg chg="mod">
          <ac:chgData name="Sonya Moore" userId="S::sonya.moore@unimelb.edu.au::d4cb55d6-0971-4265-b578-07a12dd66407" providerId="AD" clId="Web-{865F4B41-67EC-CAED-8862-3E5426A5A7BA}" dt="2022-12-02T05:35:34.700" v="146" actId="20577"/>
          <ac:spMkLst>
            <pc:docMk/>
            <pc:sldMk cId="2581054229" sldId="259"/>
            <ac:spMk id="10" creationId="{E7876974-6053-1EDB-9481-E3AEE7DF3C2B}"/>
          </ac:spMkLst>
        </pc:spChg>
        <pc:spChg chg="mod">
          <ac:chgData name="Sonya Moore" userId="S::sonya.moore@unimelb.edu.au::d4cb55d6-0971-4265-b578-07a12dd66407" providerId="AD" clId="Web-{865F4B41-67EC-CAED-8862-3E5426A5A7BA}" dt="2022-12-02T05:31:31.162" v="125" actId="20577"/>
          <ac:spMkLst>
            <pc:docMk/>
            <pc:sldMk cId="2581054229" sldId="259"/>
            <ac:spMk id="12" creationId="{FFADBD70-F23B-B1ED-8258-3CC86B56C21C}"/>
          </ac:spMkLst>
        </pc:spChg>
        <pc:spChg chg="mod">
          <ac:chgData name="Sonya Moore" userId="S::sonya.moore@unimelb.edu.au::d4cb55d6-0971-4265-b578-07a12dd66407" providerId="AD" clId="Web-{865F4B41-67EC-CAED-8862-3E5426A5A7BA}" dt="2022-12-02T05:35:40.841" v="147" actId="14100"/>
          <ac:spMkLst>
            <pc:docMk/>
            <pc:sldMk cId="2581054229" sldId="259"/>
            <ac:spMk id="32" creationId="{3E42A187-F453-2024-C551-903F7FCC7218}"/>
          </ac:spMkLst>
        </pc:spChg>
      </pc:sldChg>
    </pc:docChg>
  </pc:docChgLst>
  <pc:docChgLst>
    <pc:chgData name="Sonya Moore" userId="S::sonya.moore@unimelb.edu.au::d4cb55d6-0971-4265-b578-07a12dd66407" providerId="AD" clId="Web-{A9DFF6A4-9388-6AA4-48DB-71A0FFD98DB2}"/>
    <pc:docChg chg="modSld">
      <pc:chgData name="Sonya Moore" userId="S::sonya.moore@unimelb.edu.au::d4cb55d6-0971-4265-b578-07a12dd66407" providerId="AD" clId="Web-{A9DFF6A4-9388-6AA4-48DB-71A0FFD98DB2}" dt="2022-10-27T23:25:35.847" v="137" actId="20577"/>
      <pc:docMkLst>
        <pc:docMk/>
      </pc:docMkLst>
      <pc:sldChg chg="modSp">
        <pc:chgData name="Sonya Moore" userId="S::sonya.moore@unimelb.edu.au::d4cb55d6-0971-4265-b578-07a12dd66407" providerId="AD" clId="Web-{A9DFF6A4-9388-6AA4-48DB-71A0FFD98DB2}" dt="2022-10-27T23:18:16.963" v="85"/>
        <pc:sldMkLst>
          <pc:docMk/>
          <pc:sldMk cId="3073807009" sldId="257"/>
        </pc:sldMkLst>
        <pc:graphicFrameChg chg="mod modGraphic">
          <ac:chgData name="Sonya Moore" userId="S::sonya.moore@unimelb.edu.au::d4cb55d6-0971-4265-b578-07a12dd66407" providerId="AD" clId="Web-{A9DFF6A4-9388-6AA4-48DB-71A0FFD98DB2}" dt="2022-10-27T23:18:16.963" v="85"/>
          <ac:graphicFrameMkLst>
            <pc:docMk/>
            <pc:sldMk cId="3073807009" sldId="257"/>
            <ac:graphicFrameMk id="13" creationId="{E6DCDEED-A15C-8956-2D72-5C15B14969F2}"/>
          </ac:graphicFrameMkLst>
        </pc:graphicFrameChg>
      </pc:sldChg>
      <pc:sldChg chg="modSp">
        <pc:chgData name="Sonya Moore" userId="S::sonya.moore@unimelb.edu.au::d4cb55d6-0971-4265-b578-07a12dd66407" providerId="AD" clId="Web-{A9DFF6A4-9388-6AA4-48DB-71A0FFD98DB2}" dt="2022-10-27T23:25:35.847" v="137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A9DFF6A4-9388-6AA4-48DB-71A0FFD98DB2}" dt="2022-10-27T23:24:54.940" v="124" actId="14100"/>
          <ac:spMkLst>
            <pc:docMk/>
            <pc:sldMk cId="2581054229" sldId="259"/>
            <ac:spMk id="3" creationId="{C15C7F19-2163-4839-0F59-4B6F2F2CA5AA}"/>
          </ac:spMkLst>
        </pc:spChg>
        <pc:spChg chg="mod">
          <ac:chgData name="Sonya Moore" userId="S::sonya.moore@unimelb.edu.au::d4cb55d6-0971-4265-b578-07a12dd66407" providerId="AD" clId="Web-{A9DFF6A4-9388-6AA4-48DB-71A0FFD98DB2}" dt="2022-10-27T23:24:44.752" v="122" actId="20577"/>
          <ac:spMkLst>
            <pc:docMk/>
            <pc:sldMk cId="2581054229" sldId="259"/>
            <ac:spMk id="4" creationId="{17618A50-63C7-FFE2-3833-36B56C2C9543}"/>
          </ac:spMkLst>
        </pc:spChg>
        <pc:spChg chg="mod">
          <ac:chgData name="Sonya Moore" userId="S::sonya.moore@unimelb.edu.au::d4cb55d6-0971-4265-b578-07a12dd66407" providerId="AD" clId="Web-{A9DFF6A4-9388-6AA4-48DB-71A0FFD98DB2}" dt="2022-10-27T23:25:35.847" v="137" actId="20577"/>
          <ac:spMkLst>
            <pc:docMk/>
            <pc:sldMk cId="2581054229" sldId="259"/>
            <ac:spMk id="6" creationId="{B17B67D0-0909-5416-8EF8-E6015664302F}"/>
          </ac:spMkLst>
        </pc:spChg>
        <pc:spChg chg="mod">
          <ac:chgData name="Sonya Moore" userId="S::sonya.moore@unimelb.edu.au::d4cb55d6-0971-4265-b578-07a12dd66407" providerId="AD" clId="Web-{A9DFF6A4-9388-6AA4-48DB-71A0FFD98DB2}" dt="2022-10-27T23:24:31.986" v="117" actId="20577"/>
          <ac:spMkLst>
            <pc:docMk/>
            <pc:sldMk cId="2581054229" sldId="259"/>
            <ac:spMk id="10" creationId="{E7876974-6053-1EDB-9481-E3AEE7DF3C2B}"/>
          </ac:spMkLst>
        </pc:spChg>
        <pc:spChg chg="mod">
          <ac:chgData name="Sonya Moore" userId="S::sonya.moore@unimelb.edu.au::d4cb55d6-0971-4265-b578-07a12dd66407" providerId="AD" clId="Web-{A9DFF6A4-9388-6AA4-48DB-71A0FFD98DB2}" dt="2022-10-27T23:24:49.877" v="123" actId="14100"/>
          <ac:spMkLst>
            <pc:docMk/>
            <pc:sldMk cId="2581054229" sldId="259"/>
            <ac:spMk id="31" creationId="{318006BD-AC7E-8A30-01F6-8A4B5C40D4C8}"/>
          </ac:spMkLst>
        </pc:spChg>
        <pc:spChg chg="mod">
          <ac:chgData name="Sonya Moore" userId="S::sonya.moore@unimelb.edu.au::d4cb55d6-0971-4265-b578-07a12dd66407" providerId="AD" clId="Web-{A9DFF6A4-9388-6AA4-48DB-71A0FFD98DB2}" dt="2022-10-27T23:25:10.940" v="126" actId="1076"/>
          <ac:spMkLst>
            <pc:docMk/>
            <pc:sldMk cId="2581054229" sldId="259"/>
            <ac:spMk id="32" creationId="{3E42A187-F453-2024-C551-903F7FCC7218}"/>
          </ac:spMkLst>
        </pc:spChg>
        <pc:grpChg chg="mod">
          <ac:chgData name="Sonya Moore" userId="S::sonya.moore@unimelb.edu.au::d4cb55d6-0971-4265-b578-07a12dd66407" providerId="AD" clId="Web-{A9DFF6A4-9388-6AA4-48DB-71A0FFD98DB2}" dt="2022-10-27T23:25:06.596" v="125" actId="1076"/>
          <ac:grpSpMkLst>
            <pc:docMk/>
            <pc:sldMk cId="2581054229" sldId="259"/>
            <ac:grpSpMk id="13" creationId="{283E00A4-4F5B-956A-653D-C75DDB481053}"/>
          </ac:grpSpMkLst>
        </pc:grpChg>
      </pc:sldChg>
    </pc:docChg>
  </pc:docChgLst>
  <pc:docChgLst>
    <pc:chgData name="Sonya Moore" userId="S::sonya.moore@unimelb.edu.au::d4cb55d6-0971-4265-b578-07a12dd66407" providerId="AD" clId="Web-{F98BF479-A884-6AEF-8417-F986890E20EB}"/>
    <pc:docChg chg="modSld">
      <pc:chgData name="Sonya Moore" userId="S::sonya.moore@unimelb.edu.au::d4cb55d6-0971-4265-b578-07a12dd66407" providerId="AD" clId="Web-{F98BF479-A884-6AEF-8417-F986890E20EB}" dt="2022-08-03T01:18:58.622" v="71" actId="20577"/>
      <pc:docMkLst>
        <pc:docMk/>
      </pc:docMkLst>
      <pc:sldChg chg="modSp">
        <pc:chgData name="Sonya Moore" userId="S::sonya.moore@unimelb.edu.au::d4cb55d6-0971-4265-b578-07a12dd66407" providerId="AD" clId="Web-{F98BF479-A884-6AEF-8417-F986890E20EB}" dt="2022-08-03T01:14:34.648" v="59"/>
        <pc:sldMkLst>
          <pc:docMk/>
          <pc:sldMk cId="3073807009" sldId="257"/>
        </pc:sldMkLst>
        <pc:graphicFrameChg chg="mod modGraphic">
          <ac:chgData name="Sonya Moore" userId="S::sonya.moore@unimelb.edu.au::d4cb55d6-0971-4265-b578-07a12dd66407" providerId="AD" clId="Web-{F98BF479-A884-6AEF-8417-F986890E20EB}" dt="2022-08-03T01:14:34.648" v="59"/>
          <ac:graphicFrameMkLst>
            <pc:docMk/>
            <pc:sldMk cId="3073807009" sldId="257"/>
            <ac:graphicFrameMk id="13" creationId="{E6DCDEED-A15C-8956-2D72-5C15B14969F2}"/>
          </ac:graphicFrameMkLst>
        </pc:graphicFrameChg>
      </pc:sldChg>
      <pc:sldChg chg="modSp">
        <pc:chgData name="Sonya Moore" userId="S::sonya.moore@unimelb.edu.au::d4cb55d6-0971-4265-b578-07a12dd66407" providerId="AD" clId="Web-{F98BF479-A884-6AEF-8417-F986890E20EB}" dt="2022-08-03T01:18:58.622" v="71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F98BF479-A884-6AEF-8417-F986890E20EB}" dt="2022-08-03T01:18:58.622" v="71" actId="20577"/>
          <ac:spMkLst>
            <pc:docMk/>
            <pc:sldMk cId="2581054229" sldId="259"/>
            <ac:spMk id="4" creationId="{17618A50-63C7-FFE2-3833-36B56C2C9543}"/>
          </ac:spMkLst>
        </pc:spChg>
        <pc:spChg chg="mod">
          <ac:chgData name="Sonya Moore" userId="S::sonya.moore@unimelb.edu.au::d4cb55d6-0971-4265-b578-07a12dd66407" providerId="AD" clId="Web-{F98BF479-A884-6AEF-8417-F986890E20EB}" dt="2022-08-03T01:18:53.294" v="69" actId="20577"/>
          <ac:spMkLst>
            <pc:docMk/>
            <pc:sldMk cId="2581054229" sldId="259"/>
            <ac:spMk id="6" creationId="{B17B67D0-0909-5416-8EF8-E6015664302F}"/>
          </ac:spMkLst>
        </pc:spChg>
        <pc:spChg chg="mod">
          <ac:chgData name="Sonya Moore" userId="S::sonya.moore@unimelb.edu.au::d4cb55d6-0971-4265-b578-07a12dd66407" providerId="AD" clId="Web-{F98BF479-A884-6AEF-8417-F986890E20EB}" dt="2022-08-03T01:18:48.622" v="67" actId="20577"/>
          <ac:spMkLst>
            <pc:docMk/>
            <pc:sldMk cId="2581054229" sldId="259"/>
            <ac:spMk id="10" creationId="{E7876974-6053-1EDB-9481-E3AEE7DF3C2B}"/>
          </ac:spMkLst>
        </pc:spChg>
      </pc:sldChg>
    </pc:docChg>
  </pc:docChgLst>
  <pc:docChgLst>
    <pc:chgData name="Sonya Moore" userId="S::sonya.moore@unimelb.edu.au::d4cb55d6-0971-4265-b578-07a12dd66407" providerId="AD" clId="Web-{E9FBED84-977E-2948-871D-3C0648642F75}"/>
    <pc:docChg chg="modSld">
      <pc:chgData name="Sonya Moore" userId="S::sonya.moore@unimelb.edu.au::d4cb55d6-0971-4265-b578-07a12dd66407" providerId="AD" clId="Web-{E9FBED84-977E-2948-871D-3C0648642F75}" dt="2022-10-28T00:01:01.015" v="417"/>
      <pc:docMkLst>
        <pc:docMk/>
      </pc:docMkLst>
      <pc:sldChg chg="modSp">
        <pc:chgData name="Sonya Moore" userId="S::sonya.moore@unimelb.edu.au::d4cb55d6-0971-4265-b578-07a12dd66407" providerId="AD" clId="Web-{E9FBED84-977E-2948-871D-3C0648642F75}" dt="2022-10-28T00:01:01.015" v="417"/>
        <pc:sldMkLst>
          <pc:docMk/>
          <pc:sldMk cId="3073807009" sldId="257"/>
        </pc:sldMkLst>
        <pc:spChg chg="mod">
          <ac:chgData name="Sonya Moore" userId="S::sonya.moore@unimelb.edu.au::d4cb55d6-0971-4265-b578-07a12dd66407" providerId="AD" clId="Web-{E9FBED84-977E-2948-871D-3C0648642F75}" dt="2022-10-27T23:59:35.668" v="401" actId="1076"/>
          <ac:spMkLst>
            <pc:docMk/>
            <pc:sldMk cId="3073807009" sldId="257"/>
            <ac:spMk id="3" creationId="{46496AC5-B1F9-D890-2695-25CCF398C315}"/>
          </ac:spMkLst>
        </pc:spChg>
        <pc:spChg chg="mod">
          <ac:chgData name="Sonya Moore" userId="S::sonya.moore@unimelb.edu.au::d4cb55d6-0971-4265-b578-07a12dd66407" providerId="AD" clId="Web-{E9FBED84-977E-2948-871D-3C0648642F75}" dt="2022-10-27T23:57:28.944" v="385" actId="14100"/>
          <ac:spMkLst>
            <pc:docMk/>
            <pc:sldMk cId="3073807009" sldId="257"/>
            <ac:spMk id="14" creationId="{7497E291-4770-D565-AD05-186A62654077}"/>
          </ac:spMkLst>
        </pc:spChg>
        <pc:spChg chg="mod">
          <ac:chgData name="Sonya Moore" userId="S::sonya.moore@unimelb.edu.au::d4cb55d6-0971-4265-b578-07a12dd66407" providerId="AD" clId="Web-{E9FBED84-977E-2948-871D-3C0648642F75}" dt="2022-10-27T23:58:43.181" v="395" actId="1076"/>
          <ac:spMkLst>
            <pc:docMk/>
            <pc:sldMk cId="3073807009" sldId="257"/>
            <ac:spMk id="22" creationId="{621E862D-B914-C8EB-CD32-E12AD70C3347}"/>
          </ac:spMkLst>
        </pc:spChg>
        <pc:spChg chg="mod">
          <ac:chgData name="Sonya Moore" userId="S::sonya.moore@unimelb.edu.au::d4cb55d6-0971-4265-b578-07a12dd66407" providerId="AD" clId="Web-{E9FBED84-977E-2948-871D-3C0648642F75}" dt="2022-10-27T23:58:45.900" v="396" actId="1076"/>
          <ac:spMkLst>
            <pc:docMk/>
            <pc:sldMk cId="3073807009" sldId="257"/>
            <ac:spMk id="26" creationId="{CC9B92A2-8E6C-227C-DDD5-E7AA22C7D6B9}"/>
          </ac:spMkLst>
        </pc:spChg>
        <pc:graphicFrameChg chg="modGraphic">
          <ac:chgData name="Sonya Moore" userId="S::sonya.moore@unimelb.edu.au::d4cb55d6-0971-4265-b578-07a12dd66407" providerId="AD" clId="Web-{E9FBED84-977E-2948-871D-3C0648642F75}" dt="2022-10-27T23:58:33.665" v="393"/>
          <ac:graphicFrameMkLst>
            <pc:docMk/>
            <pc:sldMk cId="3073807009" sldId="257"/>
            <ac:graphicFrameMk id="6" creationId="{EC7BFB03-EB40-1522-D251-FE0114679E0F}"/>
          </ac:graphicFrameMkLst>
        </pc:graphicFrameChg>
        <pc:graphicFrameChg chg="mod modGraphic">
          <ac:chgData name="Sonya Moore" userId="S::sonya.moore@unimelb.edu.au::d4cb55d6-0971-4265-b578-07a12dd66407" providerId="AD" clId="Web-{E9FBED84-977E-2948-871D-3C0648642F75}" dt="2022-10-28T00:00:35.983" v="409"/>
          <ac:graphicFrameMkLst>
            <pc:docMk/>
            <pc:sldMk cId="3073807009" sldId="257"/>
            <ac:graphicFrameMk id="13" creationId="{E6DCDEED-A15C-8956-2D72-5C15B14969F2}"/>
          </ac:graphicFrameMkLst>
        </pc:graphicFrameChg>
        <pc:graphicFrameChg chg="mod modGraphic">
          <ac:chgData name="Sonya Moore" userId="S::sonya.moore@unimelb.edu.au::d4cb55d6-0971-4265-b578-07a12dd66407" providerId="AD" clId="Web-{E9FBED84-977E-2948-871D-3C0648642F75}" dt="2022-10-28T00:00:58.077" v="415"/>
          <ac:graphicFrameMkLst>
            <pc:docMk/>
            <pc:sldMk cId="3073807009" sldId="257"/>
            <ac:graphicFrameMk id="17" creationId="{C8377B3A-0B52-2DD3-83D8-9BF443349E95}"/>
          </ac:graphicFrameMkLst>
        </pc:graphicFrameChg>
        <pc:graphicFrameChg chg="mod modGraphic">
          <ac:chgData name="Sonya Moore" userId="S::sonya.moore@unimelb.edu.au::d4cb55d6-0971-4265-b578-07a12dd66407" providerId="AD" clId="Web-{E9FBED84-977E-2948-871D-3C0648642F75}" dt="2022-10-28T00:01:01.015" v="417"/>
          <ac:graphicFrameMkLst>
            <pc:docMk/>
            <pc:sldMk cId="3073807009" sldId="257"/>
            <ac:graphicFrameMk id="19" creationId="{79ED4805-FF5A-4A86-35B2-923208692049}"/>
          </ac:graphicFrameMkLst>
        </pc:graphicFrameChg>
      </pc:sldChg>
    </pc:docChg>
  </pc:docChgLst>
  <pc:docChgLst>
    <pc:chgData name="Sonya Moore" userId="S::sonya.moore@unimelb.edu.au::d4cb55d6-0971-4265-b578-07a12dd66407" providerId="AD" clId="Web-{88076702-A3C5-56E5-ED76-6CD22C87E19D}"/>
    <pc:docChg chg="modSld">
      <pc:chgData name="Sonya Moore" userId="S::sonya.moore@unimelb.edu.au::d4cb55d6-0971-4265-b578-07a12dd66407" providerId="AD" clId="Web-{88076702-A3C5-56E5-ED76-6CD22C87E19D}" dt="2023-04-05T03:54:47.802" v="70" actId="20577"/>
      <pc:docMkLst>
        <pc:docMk/>
      </pc:docMkLst>
      <pc:sldChg chg="modSp">
        <pc:chgData name="Sonya Moore" userId="S::sonya.moore@unimelb.edu.au::d4cb55d6-0971-4265-b578-07a12dd66407" providerId="AD" clId="Web-{88076702-A3C5-56E5-ED76-6CD22C87E19D}" dt="2023-04-05T03:50:33.136" v="25" actId="20577"/>
        <pc:sldMkLst>
          <pc:docMk/>
          <pc:sldMk cId="1341896371" sldId="258"/>
        </pc:sldMkLst>
        <pc:spChg chg="mod">
          <ac:chgData name="Sonya Moore" userId="S::sonya.moore@unimelb.edu.au::d4cb55d6-0971-4265-b578-07a12dd66407" providerId="AD" clId="Web-{88076702-A3C5-56E5-ED76-6CD22C87E19D}" dt="2023-04-05T03:50:33.136" v="25" actId="20577"/>
          <ac:spMkLst>
            <pc:docMk/>
            <pc:sldMk cId="1341896371" sldId="258"/>
            <ac:spMk id="6" creationId="{44EB017F-D1C1-D896-2294-38687B39A637}"/>
          </ac:spMkLst>
        </pc:spChg>
      </pc:sldChg>
      <pc:sldChg chg="modSp">
        <pc:chgData name="Sonya Moore" userId="S::sonya.moore@unimelb.edu.au::d4cb55d6-0971-4265-b578-07a12dd66407" providerId="AD" clId="Web-{88076702-A3C5-56E5-ED76-6CD22C87E19D}" dt="2023-04-05T03:54:47.802" v="70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88076702-A3C5-56E5-ED76-6CD22C87E19D}" dt="2023-04-05T03:54:40.223" v="68" actId="20577"/>
          <ac:spMkLst>
            <pc:docMk/>
            <pc:sldMk cId="2581054229" sldId="259"/>
            <ac:spMk id="4" creationId="{17618A50-63C7-FFE2-3833-36B56C2C9543}"/>
          </ac:spMkLst>
        </pc:spChg>
        <pc:spChg chg="mod">
          <ac:chgData name="Sonya Moore" userId="S::sonya.moore@unimelb.edu.au::d4cb55d6-0971-4265-b578-07a12dd66407" providerId="AD" clId="Web-{88076702-A3C5-56E5-ED76-6CD22C87E19D}" dt="2023-04-05T03:54:36.176" v="67" actId="20577"/>
          <ac:spMkLst>
            <pc:docMk/>
            <pc:sldMk cId="2581054229" sldId="259"/>
            <ac:spMk id="6" creationId="{B17B67D0-0909-5416-8EF8-E6015664302F}"/>
          </ac:spMkLst>
        </pc:spChg>
        <pc:spChg chg="mod">
          <ac:chgData name="Sonya Moore" userId="S::sonya.moore@unimelb.edu.au::d4cb55d6-0971-4265-b578-07a12dd66407" providerId="AD" clId="Web-{88076702-A3C5-56E5-ED76-6CD22C87E19D}" dt="2023-04-05T03:50:58.606" v="39" actId="20577"/>
          <ac:spMkLst>
            <pc:docMk/>
            <pc:sldMk cId="2581054229" sldId="259"/>
            <ac:spMk id="8" creationId="{8F52D4FF-CCDB-12DF-1E74-45DA6C3C6F94}"/>
          </ac:spMkLst>
        </pc:spChg>
        <pc:spChg chg="mod">
          <ac:chgData name="Sonya Moore" userId="S::sonya.moore@unimelb.edu.au::d4cb55d6-0971-4265-b578-07a12dd66407" providerId="AD" clId="Web-{88076702-A3C5-56E5-ED76-6CD22C87E19D}" dt="2023-04-05T03:54:25.551" v="65" actId="20577"/>
          <ac:spMkLst>
            <pc:docMk/>
            <pc:sldMk cId="2581054229" sldId="259"/>
            <ac:spMk id="10" creationId="{E7876974-6053-1EDB-9481-E3AEE7DF3C2B}"/>
          </ac:spMkLst>
        </pc:spChg>
        <pc:spChg chg="mod">
          <ac:chgData name="Sonya Moore" userId="S::sonya.moore@unimelb.edu.au::d4cb55d6-0971-4265-b578-07a12dd66407" providerId="AD" clId="Web-{88076702-A3C5-56E5-ED76-6CD22C87E19D}" dt="2023-04-05T03:54:47.802" v="70" actId="20577"/>
          <ac:spMkLst>
            <pc:docMk/>
            <pc:sldMk cId="2581054229" sldId="259"/>
            <ac:spMk id="12" creationId="{FFADBD70-F23B-B1ED-8258-3CC86B56C21C}"/>
          </ac:spMkLst>
        </pc:spChg>
        <pc:spChg chg="mod">
          <ac:chgData name="Sonya Moore" userId="S::sonya.moore@unimelb.edu.au::d4cb55d6-0971-4265-b578-07a12dd66407" providerId="AD" clId="Web-{88076702-A3C5-56E5-ED76-6CD22C87E19D}" dt="2023-04-05T03:53:17.158" v="63" actId="1076"/>
          <ac:spMkLst>
            <pc:docMk/>
            <pc:sldMk cId="2581054229" sldId="259"/>
            <ac:spMk id="17" creationId="{F728A211-AFC1-DB54-69AD-EEF31A404FF4}"/>
          </ac:spMkLst>
        </pc:spChg>
      </pc:sldChg>
    </pc:docChg>
  </pc:docChgLst>
  <pc:docChgLst>
    <pc:chgData name="Sonya Moore" userId="S::sonya.moore@unimelb.edu.au::d4cb55d6-0971-4265-b578-07a12dd66407" providerId="AD" clId="Web-{F5C143F0-CA58-1917-CA61-E3A6DECEBBE8}"/>
    <pc:docChg chg="delSld modSld">
      <pc:chgData name="Sonya Moore" userId="S::sonya.moore@unimelb.edu.au::d4cb55d6-0971-4265-b578-07a12dd66407" providerId="AD" clId="Web-{F5C143F0-CA58-1917-CA61-E3A6DECEBBE8}" dt="2023-04-05T03:44:43.825" v="1"/>
      <pc:docMkLst>
        <pc:docMk/>
      </pc:docMkLst>
      <pc:sldChg chg="del">
        <pc:chgData name="Sonya Moore" userId="S::sonya.moore@unimelb.edu.au::d4cb55d6-0971-4265-b578-07a12dd66407" providerId="AD" clId="Web-{F5C143F0-CA58-1917-CA61-E3A6DECEBBE8}" dt="2023-04-05T03:44:43.825" v="1"/>
        <pc:sldMkLst>
          <pc:docMk/>
          <pc:sldMk cId="3073807009" sldId="257"/>
        </pc:sldMkLst>
      </pc:sldChg>
      <pc:sldChg chg="delSp">
        <pc:chgData name="Sonya Moore" userId="S::sonya.moore@unimelb.edu.au::d4cb55d6-0971-4265-b578-07a12dd66407" providerId="AD" clId="Web-{F5C143F0-CA58-1917-CA61-E3A6DECEBBE8}" dt="2023-04-05T03:44:41.028" v="0"/>
        <pc:sldMkLst>
          <pc:docMk/>
          <pc:sldMk cId="1341896371" sldId="258"/>
        </pc:sldMkLst>
        <pc:spChg chg="del">
          <ac:chgData name="Sonya Moore" userId="S::sonya.moore@unimelb.edu.au::d4cb55d6-0971-4265-b578-07a12dd66407" providerId="AD" clId="Web-{F5C143F0-CA58-1917-CA61-E3A6DECEBBE8}" dt="2023-04-05T03:44:41.028" v="0"/>
          <ac:spMkLst>
            <pc:docMk/>
            <pc:sldMk cId="1341896371" sldId="258"/>
            <ac:spMk id="9" creationId="{7AA1B394-56FD-C8C8-E4A5-0AE4ECCAA4AB}"/>
          </ac:spMkLst>
        </pc:spChg>
      </pc:sldChg>
    </pc:docChg>
  </pc:docChgLst>
  <pc:docChgLst>
    <pc:chgData name="Sonya Jean Moore" userId="S::sonya.moore@unimelb.edu.au::d4cb55d6-0971-4265-b578-07a12dd66407" providerId="AD" clId="Web-{B514FC15-A2B0-975F-3227-8DD897A5AECF}"/>
    <pc:docChg chg="addSld delSld modSld sldOrd">
      <pc:chgData name="Sonya Jean Moore" userId="S::sonya.moore@unimelb.edu.au::d4cb55d6-0971-4265-b578-07a12dd66407" providerId="AD" clId="Web-{B514FC15-A2B0-975F-3227-8DD897A5AECF}" dt="2022-07-26T03:39:57.895" v="10" actId="20577"/>
      <pc:docMkLst>
        <pc:docMk/>
      </pc:docMkLst>
      <pc:sldChg chg="modSp">
        <pc:chgData name="Sonya Jean Moore" userId="S::sonya.moore@unimelb.edu.au::d4cb55d6-0971-4265-b578-07a12dd66407" providerId="AD" clId="Web-{B514FC15-A2B0-975F-3227-8DD897A5AECF}" dt="2022-07-26T03:39:57.895" v="10" actId="20577"/>
        <pc:sldMkLst>
          <pc:docMk/>
          <pc:sldMk cId="3073807009" sldId="257"/>
        </pc:sldMkLst>
        <pc:spChg chg="mod">
          <ac:chgData name="Sonya Jean Moore" userId="S::sonya.moore@unimelb.edu.au::d4cb55d6-0971-4265-b578-07a12dd66407" providerId="AD" clId="Web-{B514FC15-A2B0-975F-3227-8DD897A5AECF}" dt="2022-07-26T03:39:57.895" v="10" actId="20577"/>
          <ac:spMkLst>
            <pc:docMk/>
            <pc:sldMk cId="3073807009" sldId="257"/>
            <ac:spMk id="15" creationId="{419C1DB4-CDC3-DC56-8284-E5FCD628D7BA}"/>
          </ac:spMkLst>
        </pc:spChg>
      </pc:sldChg>
      <pc:sldChg chg="addSp delSp modSp">
        <pc:chgData name="Sonya Jean Moore" userId="S::sonya.moore@unimelb.edu.au::d4cb55d6-0971-4265-b578-07a12dd66407" providerId="AD" clId="Web-{B514FC15-A2B0-975F-3227-8DD897A5AECF}" dt="2022-07-26T03:39:40.192" v="8" actId="1076"/>
        <pc:sldMkLst>
          <pc:docMk/>
          <pc:sldMk cId="1341896371" sldId="258"/>
        </pc:sldMkLst>
        <pc:spChg chg="add del">
          <ac:chgData name="Sonya Jean Moore" userId="S::sonya.moore@unimelb.edu.au::d4cb55d6-0971-4265-b578-07a12dd66407" providerId="AD" clId="Web-{B514FC15-A2B0-975F-3227-8DD897A5AECF}" dt="2022-07-26T03:39:27.270" v="5"/>
          <ac:spMkLst>
            <pc:docMk/>
            <pc:sldMk cId="1341896371" sldId="258"/>
            <ac:spMk id="3" creationId="{4E420078-5BE9-74B1-7551-54AEF4F83530}"/>
          </ac:spMkLst>
        </pc:spChg>
        <pc:spChg chg="mod">
          <ac:chgData name="Sonya Jean Moore" userId="S::sonya.moore@unimelb.edu.au::d4cb55d6-0971-4265-b578-07a12dd66407" providerId="AD" clId="Web-{B514FC15-A2B0-975F-3227-8DD897A5AECF}" dt="2022-07-26T03:39:14.004" v="3" actId="20577"/>
          <ac:spMkLst>
            <pc:docMk/>
            <pc:sldMk cId="1341896371" sldId="258"/>
            <ac:spMk id="5" creationId="{CE903BE7-AD68-7EDC-655D-6F95C116E94B}"/>
          </ac:spMkLst>
        </pc:spChg>
        <pc:spChg chg="add mod">
          <ac:chgData name="Sonya Jean Moore" userId="S::sonya.moore@unimelb.edu.au::d4cb55d6-0971-4265-b578-07a12dd66407" providerId="AD" clId="Web-{B514FC15-A2B0-975F-3227-8DD897A5AECF}" dt="2022-07-26T03:39:40.192" v="8" actId="1076"/>
          <ac:spMkLst>
            <pc:docMk/>
            <pc:sldMk cId="1341896371" sldId="258"/>
            <ac:spMk id="6" creationId="{44EB017F-D1C1-D896-2294-38687B39A637}"/>
          </ac:spMkLst>
        </pc:spChg>
        <pc:spChg chg="mod">
          <ac:chgData name="Sonya Jean Moore" userId="S::sonya.moore@unimelb.edu.au::d4cb55d6-0971-4265-b578-07a12dd66407" providerId="AD" clId="Web-{B514FC15-A2B0-975F-3227-8DD897A5AECF}" dt="2022-07-26T03:39:31.770" v="6" actId="1076"/>
          <ac:spMkLst>
            <pc:docMk/>
            <pc:sldMk cId="1341896371" sldId="258"/>
            <ac:spMk id="9" creationId="{7AA1B394-56FD-C8C8-E4A5-0AE4ECCAA4AB}"/>
          </ac:spMkLst>
        </pc:spChg>
      </pc:sldChg>
      <pc:sldChg chg="add ord">
        <pc:chgData name="Sonya Jean Moore" userId="S::sonya.moore@unimelb.edu.au::d4cb55d6-0971-4265-b578-07a12dd66407" providerId="AD" clId="Web-{B514FC15-A2B0-975F-3227-8DD897A5AECF}" dt="2022-07-26T03:39:09.441" v="2"/>
        <pc:sldMkLst>
          <pc:docMk/>
          <pc:sldMk cId="2581054229" sldId="259"/>
        </pc:sldMkLst>
      </pc:sldChg>
      <pc:sldChg chg="add del">
        <pc:chgData name="Sonya Jean Moore" userId="S::sonya.moore@unimelb.edu.au::d4cb55d6-0971-4265-b578-07a12dd66407" providerId="AD" clId="Web-{B514FC15-A2B0-975F-3227-8DD897A5AECF}" dt="2022-07-26T03:39:44.551" v="9"/>
        <pc:sldMkLst>
          <pc:docMk/>
          <pc:sldMk cId="1998707704" sldId="260"/>
        </pc:sldMkLst>
      </pc:sldChg>
    </pc:docChg>
  </pc:docChgLst>
  <pc:docChgLst>
    <pc:chgData name="Sonya Moore" userId="S::sonya.moore@unimelb.edu.au::d4cb55d6-0971-4265-b578-07a12dd66407" providerId="AD" clId="Web-{C52A1873-C7D1-D577-1FF5-C5DD69177EB9}"/>
    <pc:docChg chg="modSld">
      <pc:chgData name="Sonya Moore" userId="S::sonya.moore@unimelb.edu.au::d4cb55d6-0971-4265-b578-07a12dd66407" providerId="AD" clId="Web-{C52A1873-C7D1-D577-1FF5-C5DD69177EB9}" dt="2022-10-21T22:59:51.558" v="50" actId="20577"/>
      <pc:docMkLst>
        <pc:docMk/>
      </pc:docMkLst>
      <pc:sldChg chg="modSp">
        <pc:chgData name="Sonya Moore" userId="S::sonya.moore@unimelb.edu.au::d4cb55d6-0971-4265-b578-07a12dd66407" providerId="AD" clId="Web-{C52A1873-C7D1-D577-1FF5-C5DD69177EB9}" dt="2022-10-21T22:59:51.558" v="50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C52A1873-C7D1-D577-1FF5-C5DD69177EB9}" dt="2022-10-21T22:59:51.558" v="50" actId="20577"/>
          <ac:spMkLst>
            <pc:docMk/>
            <pc:sldMk cId="2581054229" sldId="259"/>
            <ac:spMk id="12" creationId="{FFADBD70-F23B-B1ED-8258-3CC86B56C21C}"/>
          </ac:spMkLst>
        </pc:spChg>
      </pc:sldChg>
    </pc:docChg>
  </pc:docChgLst>
  <pc:docChgLst>
    <pc:chgData name="Sonya Jean Moore" userId="S::sonya.moore@unimelb.edu.au::d4cb55d6-0971-4265-b578-07a12dd66407" providerId="AD" clId="Web-{BE0A897C-FD4D-F0DA-7D8C-AD07EA7D8F44}"/>
    <pc:docChg chg="modSld">
      <pc:chgData name="Sonya Jean Moore" userId="S::sonya.moore@unimelb.edu.au::d4cb55d6-0971-4265-b578-07a12dd66407" providerId="AD" clId="Web-{BE0A897C-FD4D-F0DA-7D8C-AD07EA7D8F44}" dt="2022-07-29T03:03:00.013" v="42" actId="20577"/>
      <pc:docMkLst>
        <pc:docMk/>
      </pc:docMkLst>
      <pc:sldChg chg="modSp">
        <pc:chgData name="Sonya Jean Moore" userId="S::sonya.moore@unimelb.edu.au::d4cb55d6-0971-4265-b578-07a12dd66407" providerId="AD" clId="Web-{BE0A897C-FD4D-F0DA-7D8C-AD07EA7D8F44}" dt="2022-07-29T02:59:31.453" v="33"/>
        <pc:sldMkLst>
          <pc:docMk/>
          <pc:sldMk cId="3073807009" sldId="257"/>
        </pc:sldMkLst>
        <pc:graphicFrameChg chg="mod modGraphic">
          <ac:chgData name="Sonya Jean Moore" userId="S::sonya.moore@unimelb.edu.au::d4cb55d6-0971-4265-b578-07a12dd66407" providerId="AD" clId="Web-{BE0A897C-FD4D-F0DA-7D8C-AD07EA7D8F44}" dt="2022-07-29T02:59:31.453" v="33"/>
          <ac:graphicFrameMkLst>
            <pc:docMk/>
            <pc:sldMk cId="3073807009" sldId="257"/>
            <ac:graphicFrameMk id="23" creationId="{C1FC9272-5F3C-D1FF-5E7D-1EA18BCC05C7}"/>
          </ac:graphicFrameMkLst>
        </pc:graphicFrameChg>
      </pc:sldChg>
      <pc:sldChg chg="modSp">
        <pc:chgData name="Sonya Jean Moore" userId="S::sonya.moore@unimelb.edu.au::d4cb55d6-0971-4265-b578-07a12dd66407" providerId="AD" clId="Web-{BE0A897C-FD4D-F0DA-7D8C-AD07EA7D8F44}" dt="2022-07-29T03:03:00.013" v="42" actId="20577"/>
        <pc:sldMkLst>
          <pc:docMk/>
          <pc:sldMk cId="2581054229" sldId="259"/>
        </pc:sldMkLst>
        <pc:spChg chg="mod">
          <ac:chgData name="Sonya Jean Moore" userId="S::sonya.moore@unimelb.edu.au::d4cb55d6-0971-4265-b578-07a12dd66407" providerId="AD" clId="Web-{BE0A897C-FD4D-F0DA-7D8C-AD07EA7D8F44}" dt="2022-07-29T03:01:47.805" v="38" actId="20577"/>
          <ac:spMkLst>
            <pc:docMk/>
            <pc:sldMk cId="2581054229" sldId="259"/>
            <ac:spMk id="6" creationId="{B17B67D0-0909-5416-8EF8-E6015664302F}"/>
          </ac:spMkLst>
        </pc:spChg>
        <pc:spChg chg="mod">
          <ac:chgData name="Sonya Jean Moore" userId="S::sonya.moore@unimelb.edu.au::d4cb55d6-0971-4265-b578-07a12dd66407" providerId="AD" clId="Web-{BE0A897C-FD4D-F0DA-7D8C-AD07EA7D8F44}" dt="2022-07-29T03:03:00.013" v="42" actId="20577"/>
          <ac:spMkLst>
            <pc:docMk/>
            <pc:sldMk cId="2581054229" sldId="259"/>
            <ac:spMk id="10" creationId="{E7876974-6053-1EDB-9481-E3AEE7DF3C2B}"/>
          </ac:spMkLst>
        </pc:spChg>
      </pc:sldChg>
    </pc:docChg>
  </pc:docChgLst>
  <pc:docChgLst>
    <pc:chgData name="Sonya Moore" userId="S::sonya.moore@unimelb.edu.au::d4cb55d6-0971-4265-b578-07a12dd66407" providerId="AD" clId="Web-{ED0FAD01-9A29-0335-7D1B-97569D4470EB}"/>
    <pc:docChg chg="modSld">
      <pc:chgData name="Sonya Moore" userId="S::sonya.moore@unimelb.edu.au::d4cb55d6-0971-4265-b578-07a12dd66407" providerId="AD" clId="Web-{ED0FAD01-9A29-0335-7D1B-97569D4470EB}" dt="2023-04-05T03:41:03.985" v="6" actId="20577"/>
      <pc:docMkLst>
        <pc:docMk/>
      </pc:docMkLst>
      <pc:sldChg chg="modSp">
        <pc:chgData name="Sonya Moore" userId="S::sonya.moore@unimelb.edu.au::d4cb55d6-0971-4265-b578-07a12dd66407" providerId="AD" clId="Web-{ED0FAD01-9A29-0335-7D1B-97569D4470EB}" dt="2023-04-05T03:40:53.297" v="4" actId="20577"/>
        <pc:sldMkLst>
          <pc:docMk/>
          <pc:sldMk cId="3073807009" sldId="257"/>
        </pc:sldMkLst>
        <pc:spChg chg="mod">
          <ac:chgData name="Sonya Moore" userId="S::sonya.moore@unimelb.edu.au::d4cb55d6-0971-4265-b578-07a12dd66407" providerId="AD" clId="Web-{ED0FAD01-9A29-0335-7D1B-97569D4470EB}" dt="2023-04-05T03:40:53.297" v="4" actId="20577"/>
          <ac:spMkLst>
            <pc:docMk/>
            <pc:sldMk cId="3073807009" sldId="257"/>
            <ac:spMk id="15" creationId="{419C1DB4-CDC3-DC56-8284-E5FCD628D7BA}"/>
          </ac:spMkLst>
        </pc:spChg>
      </pc:sldChg>
      <pc:sldChg chg="modSp">
        <pc:chgData name="Sonya Moore" userId="S::sonya.moore@unimelb.edu.au::d4cb55d6-0971-4265-b578-07a12dd66407" providerId="AD" clId="Web-{ED0FAD01-9A29-0335-7D1B-97569D4470EB}" dt="2023-04-05T03:40:42.297" v="1" actId="20577"/>
        <pc:sldMkLst>
          <pc:docMk/>
          <pc:sldMk cId="1341896371" sldId="258"/>
        </pc:sldMkLst>
        <pc:spChg chg="mod">
          <ac:chgData name="Sonya Moore" userId="S::sonya.moore@unimelb.edu.au::d4cb55d6-0971-4265-b578-07a12dd66407" providerId="AD" clId="Web-{ED0FAD01-9A29-0335-7D1B-97569D4470EB}" dt="2023-04-05T03:40:42.297" v="1" actId="20577"/>
          <ac:spMkLst>
            <pc:docMk/>
            <pc:sldMk cId="1341896371" sldId="258"/>
            <ac:spMk id="6" creationId="{44EB017F-D1C1-D896-2294-38687B39A637}"/>
          </ac:spMkLst>
        </pc:spChg>
        <pc:spChg chg="mod">
          <ac:chgData name="Sonya Moore" userId="S::sonya.moore@unimelb.edu.au::d4cb55d6-0971-4265-b578-07a12dd66407" providerId="AD" clId="Web-{ED0FAD01-9A29-0335-7D1B-97569D4470EB}" dt="2023-04-05T03:40:37.875" v="0" actId="20577"/>
          <ac:spMkLst>
            <pc:docMk/>
            <pc:sldMk cId="1341896371" sldId="258"/>
            <ac:spMk id="9" creationId="{7AA1B394-56FD-C8C8-E4A5-0AE4ECCAA4AB}"/>
          </ac:spMkLst>
        </pc:spChg>
      </pc:sldChg>
      <pc:sldChg chg="modSp">
        <pc:chgData name="Sonya Moore" userId="S::sonya.moore@unimelb.edu.au::d4cb55d6-0971-4265-b578-07a12dd66407" providerId="AD" clId="Web-{ED0FAD01-9A29-0335-7D1B-97569D4470EB}" dt="2023-04-05T03:41:03.985" v="6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ED0FAD01-9A29-0335-7D1B-97569D4470EB}" dt="2023-04-05T03:41:03.985" v="6" actId="20577"/>
          <ac:spMkLst>
            <pc:docMk/>
            <pc:sldMk cId="2581054229" sldId="259"/>
            <ac:spMk id="8" creationId="{8F52D4FF-CCDB-12DF-1E74-45DA6C3C6F94}"/>
          </ac:spMkLst>
        </pc:spChg>
      </pc:sldChg>
    </pc:docChg>
  </pc:docChgLst>
  <pc:docChgLst>
    <pc:chgData name="Sonya Moore" userId="S::sonya.moore@unimelb.edu.au::d4cb55d6-0971-4265-b578-07a12dd66407" providerId="AD" clId="Web-{03433229-312E-20F0-D201-2924EE22C733}"/>
    <pc:docChg chg="modSld">
      <pc:chgData name="Sonya Moore" userId="S::sonya.moore@unimelb.edu.au::d4cb55d6-0971-4265-b578-07a12dd66407" providerId="AD" clId="Web-{03433229-312E-20F0-D201-2924EE22C733}" dt="2023-05-08T13:08:28.588" v="17" actId="20577"/>
      <pc:docMkLst>
        <pc:docMk/>
      </pc:docMkLst>
      <pc:sldChg chg="modSp">
        <pc:chgData name="Sonya Moore" userId="S::sonya.moore@unimelb.edu.au::d4cb55d6-0971-4265-b578-07a12dd66407" providerId="AD" clId="Web-{03433229-312E-20F0-D201-2924EE22C733}" dt="2023-05-08T13:08:28.588" v="17" actId="20577"/>
        <pc:sldMkLst>
          <pc:docMk/>
          <pc:sldMk cId="2581054229" sldId="259"/>
        </pc:sldMkLst>
        <pc:spChg chg="mod">
          <ac:chgData name="Sonya Moore" userId="S::sonya.moore@unimelb.edu.au::d4cb55d6-0971-4265-b578-07a12dd66407" providerId="AD" clId="Web-{03433229-312E-20F0-D201-2924EE22C733}" dt="2023-05-08T13:08:28.588" v="17" actId="20577"/>
          <ac:spMkLst>
            <pc:docMk/>
            <pc:sldMk cId="2581054229" sldId="259"/>
            <ac:spMk id="12" creationId="{FFADBD70-F23B-B1ED-8258-3CC86B56C21C}"/>
          </ac:spMkLst>
        </pc:spChg>
      </pc:sldChg>
    </pc:docChg>
  </pc:docChgLst>
  <pc:docChgLst>
    <pc:chgData name="Sonya Jean Moore" userId="S::sonya.moore@unimelb.edu.au::d4cb55d6-0971-4265-b578-07a12dd66407" providerId="AD" clId="Web-{4C74D3DA-5EFC-427C-96FC-D947E5695070}"/>
    <pc:docChg chg="addSld delSld modSld addMainMaster">
      <pc:chgData name="Sonya Jean Moore" userId="S::sonya.moore@unimelb.edu.au::d4cb55d6-0971-4265-b578-07a12dd66407" providerId="AD" clId="Web-{4C74D3DA-5EFC-427C-96FC-D947E5695070}" dt="2022-06-17T08:27:16.938" v="10" actId="20577"/>
      <pc:docMkLst>
        <pc:docMk/>
      </pc:docMkLst>
      <pc:sldChg chg="del">
        <pc:chgData name="Sonya Jean Moore" userId="S::sonya.moore@unimelb.edu.au::d4cb55d6-0971-4265-b578-07a12dd66407" providerId="AD" clId="Web-{4C74D3DA-5EFC-427C-96FC-D947E5695070}" dt="2022-06-17T08:24:37.684" v="2"/>
        <pc:sldMkLst>
          <pc:docMk/>
          <pc:sldMk cId="109857222" sldId="256"/>
        </pc:sldMkLst>
      </pc:sldChg>
      <pc:sldChg chg="add">
        <pc:chgData name="Sonya Jean Moore" userId="S::sonya.moore@unimelb.edu.au::d4cb55d6-0971-4265-b578-07a12dd66407" providerId="AD" clId="Web-{4C74D3DA-5EFC-427C-96FC-D947E5695070}" dt="2022-06-17T08:24:34.200" v="0"/>
        <pc:sldMkLst>
          <pc:docMk/>
          <pc:sldMk cId="3073807009" sldId="257"/>
        </pc:sldMkLst>
      </pc:sldChg>
      <pc:sldChg chg="delSp modSp add">
        <pc:chgData name="Sonya Jean Moore" userId="S::sonya.moore@unimelb.edu.au::d4cb55d6-0971-4265-b578-07a12dd66407" providerId="AD" clId="Web-{4C74D3DA-5EFC-427C-96FC-D947E5695070}" dt="2022-06-17T08:27:16.938" v="10" actId="20577"/>
        <pc:sldMkLst>
          <pc:docMk/>
          <pc:sldMk cId="1341896371" sldId="258"/>
        </pc:sldMkLst>
        <pc:spChg chg="mod">
          <ac:chgData name="Sonya Jean Moore" userId="S::sonya.moore@unimelb.edu.au::d4cb55d6-0971-4265-b578-07a12dd66407" providerId="AD" clId="Web-{4C74D3DA-5EFC-427C-96FC-D947E5695070}" dt="2022-06-17T08:27:06.344" v="7" actId="20577"/>
          <ac:spMkLst>
            <pc:docMk/>
            <pc:sldMk cId="1341896371" sldId="258"/>
            <ac:spMk id="5" creationId="{CE903BE7-AD68-7EDC-655D-6F95C116E94B}"/>
          </ac:spMkLst>
        </pc:spChg>
        <pc:spChg chg="del">
          <ac:chgData name="Sonya Jean Moore" userId="S::sonya.moore@unimelb.edu.au::d4cb55d6-0971-4265-b578-07a12dd66407" providerId="AD" clId="Web-{4C74D3DA-5EFC-427C-96FC-D947E5695070}" dt="2022-06-17T08:24:42.715" v="3"/>
          <ac:spMkLst>
            <pc:docMk/>
            <pc:sldMk cId="1341896371" sldId="258"/>
            <ac:spMk id="7" creationId="{19DA2753-57C6-767E-97FC-77E66E00E245}"/>
          </ac:spMkLst>
        </pc:spChg>
        <pc:spChg chg="mod">
          <ac:chgData name="Sonya Jean Moore" userId="S::sonya.moore@unimelb.edu.au::d4cb55d6-0971-4265-b578-07a12dd66407" providerId="AD" clId="Web-{4C74D3DA-5EFC-427C-96FC-D947E5695070}" dt="2022-06-17T08:27:16.938" v="10" actId="20577"/>
          <ac:spMkLst>
            <pc:docMk/>
            <pc:sldMk cId="1341896371" sldId="258"/>
            <ac:spMk id="9" creationId="{7AA1B394-56FD-C8C8-E4A5-0AE4ECCAA4AB}"/>
          </ac:spMkLst>
        </pc:spChg>
        <pc:spChg chg="del">
          <ac:chgData name="Sonya Jean Moore" userId="S::sonya.moore@unimelb.edu.au::d4cb55d6-0971-4265-b578-07a12dd66407" providerId="AD" clId="Web-{4C74D3DA-5EFC-427C-96FC-D947E5695070}" dt="2022-06-17T08:24:46.231" v="4"/>
          <ac:spMkLst>
            <pc:docMk/>
            <pc:sldMk cId="1341896371" sldId="258"/>
            <ac:spMk id="11" creationId="{48BA3031-F2E7-9189-F695-214739F32D84}"/>
          </ac:spMkLst>
        </pc:spChg>
      </pc:sldChg>
      <pc:sldMasterChg chg="add addSldLayout">
        <pc:chgData name="Sonya Jean Moore" userId="S::sonya.moore@unimelb.edu.au::d4cb55d6-0971-4265-b578-07a12dd66407" providerId="AD" clId="Web-{4C74D3DA-5EFC-427C-96FC-D947E5695070}" dt="2022-06-17T08:24:34.200" v="0"/>
        <pc:sldMasterMkLst>
          <pc:docMk/>
          <pc:sldMasterMk cId="833119919" sldId="2147483648"/>
        </pc:sldMasterMkLst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1111956713" sldId="2147483649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119360991" sldId="2147483650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3730206054" sldId="2147483651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497507210" sldId="2147483652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1691816113" sldId="2147483653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3232147819" sldId="2147483654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3750728524" sldId="2147483655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1657368280" sldId="2147483656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971882853" sldId="2147483657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4123649404" sldId="2147483658"/>
          </pc:sldLayoutMkLst>
        </pc:sldLayoutChg>
        <pc:sldLayoutChg chg="add">
          <pc:chgData name="Sonya Jean Moore" userId="S::sonya.moore@unimelb.edu.au::d4cb55d6-0971-4265-b578-07a12dd66407" providerId="AD" clId="Web-{4C74D3DA-5EFC-427C-96FC-D947E5695070}" dt="2022-06-17T08:24:34.200" v="0"/>
          <pc:sldLayoutMkLst>
            <pc:docMk/>
            <pc:sldMasterMk cId="833119919" sldId="2147483648"/>
            <pc:sldLayoutMk cId="1503952709" sldId="2147483659"/>
          </pc:sldLayoutMkLst>
        </pc:sldLayoutChg>
      </pc:sldMasterChg>
    </pc:docChg>
  </pc:docChgLst>
  <pc:docChgLst>
    <pc:chgData clId="Web-{F5C143F0-CA58-1917-CA61-E3A6DECEBBE8}"/>
    <pc:docChg chg="modSld">
      <pc:chgData name="" userId="" providerId="" clId="Web-{F5C143F0-CA58-1917-CA61-E3A6DECEBBE8}" dt="2023-04-05T03:44:38.309" v="1" actId="20577"/>
      <pc:docMkLst>
        <pc:docMk/>
      </pc:docMkLst>
      <pc:sldChg chg="modSp">
        <pc:chgData name="" userId="" providerId="" clId="Web-{F5C143F0-CA58-1917-CA61-E3A6DECEBBE8}" dt="2023-04-05T03:44:38.309" v="1" actId="20577"/>
        <pc:sldMkLst>
          <pc:docMk/>
          <pc:sldMk cId="1341896371" sldId="258"/>
        </pc:sldMkLst>
        <pc:spChg chg="mod">
          <ac:chgData name="" userId="" providerId="" clId="Web-{F5C143F0-CA58-1917-CA61-E3A6DECEBBE8}" dt="2023-04-05T03:44:38.309" v="1" actId="20577"/>
          <ac:spMkLst>
            <pc:docMk/>
            <pc:sldMk cId="1341896371" sldId="258"/>
            <ac:spMk id="5" creationId="{CE903BE7-AD68-7EDC-655D-6F95C116E94B}"/>
          </ac:spMkLst>
        </pc:spChg>
      </pc:sldChg>
    </pc:docChg>
  </pc:docChgLst>
  <pc:docChgLst>
    <pc:chgData name="Sonya Jean Moore" userId="S::sonya.moore@unimelb.edu.au::d4cb55d6-0971-4265-b578-07a12dd66407" providerId="AD" clId="Web-{5D18BF64-A140-13D9-600A-1E5C299A36E4}"/>
    <pc:docChg chg="modSld">
      <pc:chgData name="Sonya Jean Moore" userId="S::sonya.moore@unimelb.edu.au::d4cb55d6-0971-4265-b578-07a12dd66407" providerId="AD" clId="Web-{5D18BF64-A140-13D9-600A-1E5C299A36E4}" dt="2022-07-25T23:53:12.056" v="0" actId="20577"/>
      <pc:docMkLst>
        <pc:docMk/>
      </pc:docMkLst>
      <pc:sldChg chg="modSp">
        <pc:chgData name="Sonya Jean Moore" userId="S::sonya.moore@unimelb.edu.au::d4cb55d6-0971-4265-b578-07a12dd66407" providerId="AD" clId="Web-{5D18BF64-A140-13D9-600A-1E5C299A36E4}" dt="2022-07-25T23:53:12.056" v="0" actId="20577"/>
        <pc:sldMkLst>
          <pc:docMk/>
          <pc:sldMk cId="1341896371" sldId="258"/>
        </pc:sldMkLst>
        <pc:spChg chg="mod">
          <ac:chgData name="Sonya Jean Moore" userId="S::sonya.moore@unimelb.edu.au::d4cb55d6-0971-4265-b578-07a12dd66407" providerId="AD" clId="Web-{5D18BF64-A140-13D9-600A-1E5C299A36E4}" dt="2022-07-25T23:53:12.056" v="0" actId="20577"/>
          <ac:spMkLst>
            <pc:docMk/>
            <pc:sldMk cId="1341896371" sldId="258"/>
            <ac:spMk id="9" creationId="{7AA1B394-56FD-C8C8-E4A5-0AE4ECCAA4A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479BD-FD5D-48B4-A354-AB1322AE9B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61DCE7-5857-4FDA-A8B7-A78892DF29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7EEE39-22D9-4392-AD98-09D94F173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AB7A41-945C-4EFB-A09E-72253D3D2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E7654-90E5-42DE-A13B-67691E8AD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195671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1A37C-7A85-44A8-9EB0-4B75BD0FFD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9EF28E-41F3-4959-92C2-B48536D1A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93D02D-A195-44AE-B1F5-51F167808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FF035D-3D81-4BEB-9F44-130D2B2C5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B1188-EEAD-43A6-B71E-B44FF608A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3609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F66CC6-61DB-4BAB-9402-AEF636C61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267DFB-6757-4ABE-A2C9-E98A7A435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D4E62-1B5B-4519-ADD5-8CE230528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FD7E9-C394-4136-A2B4-F7740A3BF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C668F-902D-4DC4-9BAD-76BEC5C64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020605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AC49E-379F-4374-9D41-24A259EC6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9F8C9E-3024-42D6-83DE-0B29E68460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B19C1B-EEEC-4B6A-B1FD-0BB4E37085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56125D-250A-42E9-AD02-48CC29B39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355B52-9B2C-4190-BB3A-F212F3861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4932D-B851-4A0C-BAEA-11727DFA4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750721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6139E-BE4F-4208-A2BD-7C1126D88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A795D-32D4-4F67-886F-58CCB5F372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D7C8F2-2A14-4046-B6A6-C26CE9D76F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4A3769C-91F9-4423-8552-CBF9DACD43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662FE4-6E83-49BC-8995-1227A9F443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E27519-E4B4-4217-8001-EABBD0CD3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176577-D9A7-488F-AC34-781550AC1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FA7599-8256-4E37-ACDF-37925655D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181611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74824-E17A-4E47-94B3-0A9C2FB9B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891616-53CC-4F90-9E0C-70FF6B850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4AF50F-D692-47B0-A82A-7622927C8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CAAC0C-01ED-4486-A65D-820F2A0BA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21478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B1CB49-EC46-4E83-ADBF-93CA0693D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DE7E40-17FA-4BEC-B014-08B925A8F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E6046B-BD3C-4553-844F-5FC88B2E2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072852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74470-7F97-4454-80A4-39A4E485B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1C0E1B-4705-458E-8888-717564EE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BC59E7-FCB6-466C-93C7-839268CDAD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8921A3-9384-47F0-92D3-DA09E9D06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E5E672-253F-4172-96D7-8FC6F5A46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B631BE-AEF5-42B2-9A74-7D011214E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7368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A83743-48E1-4DD9-80C2-51D8FC773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497287-544D-426C-8C0E-927CC2ED69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FC0FC0-F467-4114-9426-C61CA62D13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9B4B80-256A-4F86-B739-1E2CD59A8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DA8423-3362-4175-8F2C-2A18C9AC1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F0C7A9-0AC2-4E5F-831F-DA65515D1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188285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96AA0-2E9C-4474-B3B5-6C1A6D3725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0CAE16-24F4-4326-8816-8589725DF6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29CB70-5C4F-44D0-B834-ABF6EA511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75B7C2-3A4F-4197-B5FB-3F1F7F2A0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22F8F1-0293-4ABB-82A2-60504ECD7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364940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962DCC-B0F9-44FC-B7EF-D40FBF1E43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D16104-B787-46B6-978A-80ED844977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2622D-8009-4982-BE6E-E38D2D50F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D7765-F8B6-4585-84AA-09D329B19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E766C3-35B5-4B42-A56B-E88D1F80F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3952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432D04-10A2-4239-9A13-80B599316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379766-397D-4BC4-8A11-DD3B8B1CF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567A9-FF4C-4923-926D-E9EB0AF872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E4968-92E3-4938-9EA0-91EB20A7DBEB}" type="datetimeFigureOut">
              <a:rPr lang="en-AU" smtClean="0"/>
              <a:t>10/05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81E5F-A513-42B5-B5D9-60BC64A8A6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74495B-E34A-4758-9DA6-80AC1AD1FE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AC378-244B-43D2-80C3-0A029BE016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3119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CE903BE7-AD68-7EDC-655D-6F95C116E9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3296" y="353817"/>
            <a:ext cx="10515600" cy="447393"/>
          </a:xfrm>
        </p:spPr>
        <p:txBody>
          <a:bodyPr vert="horz" lIns="91440" tIns="45720" rIns="91440" bIns="45720" rtlCol="0" anchor="t">
            <a:normAutofit lnSpcReduction="10000"/>
          </a:bodyPr>
          <a:lstStyle/>
          <a:p>
            <a:pPr marL="0" indent="0">
              <a:buNone/>
            </a:pPr>
            <a:r>
              <a:rPr lang="en-US" dirty="0">
                <a:latin typeface="Times New Roman"/>
                <a:cs typeface="Calibri" panose="020F0502020204030204"/>
              </a:rPr>
              <a:t>Figure title and legen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EB017F-D1C1-D896-2294-38687B39A637}"/>
              </a:ext>
            </a:extLst>
          </p:cNvPr>
          <p:cNvSpPr txBox="1"/>
          <p:nvPr/>
        </p:nvSpPr>
        <p:spPr>
          <a:xfrm>
            <a:off x="438874" y="2465401"/>
            <a:ext cx="11488904" cy="155427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AU" sz="1200" b="1" dirty="0">
                <a:latin typeface="Times New Roman"/>
                <a:cs typeface="Times New Roman"/>
              </a:rPr>
              <a:t>Supplementary File 1. Recommendations for EPA construct and reporting: towards fidelity and application to education and practice. </a:t>
            </a:r>
            <a:r>
              <a:rPr lang="en-AU" sz="1200" dirty="0">
                <a:latin typeface="Times New Roman"/>
                <a:cs typeface="Times New Roman"/>
              </a:rPr>
              <a:t>Abbreviations: EPA, </a:t>
            </a:r>
            <a:r>
              <a:rPr lang="en-AU" sz="1200" dirty="0" err="1">
                <a:latin typeface="Times New Roman"/>
                <a:cs typeface="Times New Roman"/>
              </a:rPr>
              <a:t>Entrustable</a:t>
            </a:r>
            <a:r>
              <a:rPr lang="en-AU" sz="1200" dirty="0">
                <a:latin typeface="Times New Roman"/>
                <a:cs typeface="Times New Roman"/>
              </a:rPr>
              <a:t> Professional Activity. </a:t>
            </a:r>
          </a:p>
          <a:p>
            <a:r>
              <a:rPr lang="en-AU" sz="1200" dirty="0">
                <a:latin typeface="Times New Roman"/>
                <a:ea typeface="+mn-lt"/>
                <a:cs typeface="+mn-lt"/>
              </a:rPr>
              <a:t>This figure represents the evolving evidence and recommendations for EPA design and attributes. Further to themes identified in our scoping review, we extend interpretation of this perspective for EPA reporting. </a:t>
            </a:r>
            <a:endParaRPr lang="en-AU" sz="1200" dirty="0">
              <a:latin typeface="Times New Roman"/>
              <a:cs typeface="Calibri"/>
            </a:endParaRPr>
          </a:p>
          <a:p>
            <a:br>
              <a:rPr lang="en-US" dirty="0"/>
            </a:br>
            <a:endParaRPr lang="en-US" dirty="0"/>
          </a:p>
          <a:p>
            <a:endParaRPr lang="en-AU" sz="1100" b="1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41896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618A50-63C7-FFE2-3833-36B56C2C9543}"/>
              </a:ext>
            </a:extLst>
          </p:cNvPr>
          <p:cNvSpPr txBox="1"/>
          <p:nvPr/>
        </p:nvSpPr>
        <p:spPr>
          <a:xfrm>
            <a:off x="63948" y="992822"/>
            <a:ext cx="3328319" cy="2041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b="1" dirty="0"/>
              <a:t>Recommended EPA attributes, </a:t>
            </a:r>
            <a:r>
              <a:rPr lang="en-AU" sz="1000" b="1" dirty="0">
                <a:ea typeface="+mn-lt"/>
                <a:cs typeface="+mn-lt"/>
              </a:rPr>
              <a:t>Ten Cate (2005) (</a:t>
            </a:r>
            <a:r>
              <a:rPr lang="en-AU" sz="1000" b="1" dirty="0"/>
              <a:t>5)</a:t>
            </a:r>
            <a:br>
              <a:rPr lang="en-AU" sz="1000" b="1" dirty="0"/>
            </a:br>
            <a:endParaRPr lang="en-AU" sz="1000" b="1" baseline="30000" dirty="0">
              <a:cs typeface="Calibri"/>
            </a:endParaRPr>
          </a:p>
          <a:p>
            <a:pPr marL="228600" indent="-228600">
              <a:buAutoNum type="arabicPeriod"/>
            </a:pPr>
            <a:r>
              <a:rPr lang="en-US" sz="1000" dirty="0"/>
              <a:t>Are part of essential professional work in a given context</a:t>
            </a:r>
            <a:endParaRPr lang="en-US" sz="1000" dirty="0">
              <a:cs typeface="Calibri"/>
            </a:endParaRP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Require adequate knowledge, skill &amp; attitude, generally acquired through training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Lead to recognized output of professional labor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Usually be confined to qualified personnel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Independently executable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Executable within a time frame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Observable &amp; measurable in their process and their outcome, leading to a conclusion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Reflect one or more of the competencies to be acquir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7B67D0-0909-5416-8EF8-E6015664302F}"/>
              </a:ext>
            </a:extLst>
          </p:cNvPr>
          <p:cNvSpPr txBox="1"/>
          <p:nvPr/>
        </p:nvSpPr>
        <p:spPr>
          <a:xfrm>
            <a:off x="4070601" y="898088"/>
            <a:ext cx="3822781" cy="58872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AU" sz="1000" b="1" dirty="0">
                <a:ea typeface="+mn-lt"/>
                <a:cs typeface="+mn-lt"/>
              </a:rPr>
              <a:t>Recommended EPA description: AMEE Guide No. 140, Ten Cate &amp; Taylor (2021) (39)</a:t>
            </a:r>
            <a:br>
              <a:rPr lang="en-AU" sz="900" b="1" dirty="0">
                <a:ea typeface="+mn-lt"/>
                <a:cs typeface="+mn-lt"/>
              </a:rPr>
            </a:br>
            <a:endParaRPr lang="en-AU" sz="900" b="1" dirty="0">
              <a:ea typeface="+mn-lt"/>
              <a:cs typeface="+mn-lt"/>
            </a:endParaRPr>
          </a:p>
          <a:p>
            <a:r>
              <a:rPr lang="en-US" sz="1000" u="sng" dirty="0">
                <a:solidFill>
                  <a:srgbClr val="000000"/>
                </a:solidFill>
                <a:latin typeface="Calibri"/>
                <a:cs typeface="Calibri"/>
              </a:rPr>
              <a:t>Features:</a:t>
            </a:r>
            <a:endParaRPr lang="en-US" sz="1000" dirty="0">
              <a:solidFill>
                <a:srgbClr val="000000"/>
              </a:solidFill>
              <a:latin typeface="Calibri"/>
              <a:cs typeface="Calibri"/>
            </a:endParaRP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Clearly defined beginning &amp; end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Independently executable to achieve a defined clinical outcome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Specific &amp; focused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Observable in process &amp; measurable in outcome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Clearly distinguished from other EPAs in the framework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Reflects work that is essential &amp; important to the profession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Leads to recognized output or outcome of labor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Restricted to qualified personnel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Requires application of knowledge, skills and/or attitudes acquired through training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Involves application and integration of multiple domains of competence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Describes a task, not qualities or competencies of a learner and avoids adjectives (or adverbs) that refer to proficiency</a:t>
            </a:r>
          </a:p>
          <a:p>
            <a:pPr marL="171450" indent="-171450">
              <a:buFont typeface="Arial"/>
              <a:buChar char="•"/>
            </a:pPr>
            <a:endParaRPr lang="en-US" sz="1000" dirty="0">
              <a:cs typeface="Calibri"/>
            </a:endParaRPr>
          </a:p>
          <a:p>
            <a:r>
              <a:rPr lang="en-US" sz="1000" u="sng" dirty="0">
                <a:cs typeface="Calibri"/>
              </a:rPr>
              <a:t>Structure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EPA title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Specifications &amp; limitations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Potential risks in case of failure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Most relevant competency domains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Required knowledge, skills attitudes and experiences to allow for summative entrustment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Information sources to assess progress and support summative entrustment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Entrustment / supervision level expected at which stage of training</a:t>
            </a:r>
          </a:p>
          <a:p>
            <a:pPr marL="228600" indent="-228600">
              <a:buAutoNum type="arabicPeriod"/>
            </a:pPr>
            <a:r>
              <a:rPr lang="en-US" sz="1000" dirty="0">
                <a:cs typeface="Calibri"/>
              </a:rPr>
              <a:t>Time period to expiration if not practiced</a:t>
            </a:r>
          </a:p>
          <a:p>
            <a:pPr marL="228600" indent="-228600">
              <a:buAutoNum type="arabicPeriod"/>
            </a:pPr>
            <a:endParaRPr lang="en-US" sz="1000" dirty="0">
              <a:cs typeface="Calibri"/>
            </a:endParaRPr>
          </a:p>
          <a:p>
            <a:r>
              <a:rPr lang="en-US" sz="1000" b="1" dirty="0">
                <a:cs typeface="Calibri"/>
              </a:rPr>
              <a:t>EPA Title Recommendations</a:t>
            </a:r>
          </a:p>
          <a:p>
            <a:pPr marL="171450" indent="-171450">
              <a:buFont typeface="Arial,Sans-Serif"/>
              <a:buChar char="•"/>
            </a:pPr>
            <a:r>
              <a:rPr lang="en-US" sz="1000" dirty="0">
                <a:ea typeface="+mn-lt"/>
                <a:cs typeface="+mn-lt"/>
              </a:rPr>
              <a:t>Unambiguous</a:t>
            </a:r>
          </a:p>
          <a:p>
            <a:pPr marL="171450" indent="-171450">
              <a:buFont typeface="Arial,Sans-Serif"/>
              <a:buChar char="•"/>
            </a:pPr>
            <a:r>
              <a:rPr lang="en-US" sz="1000" dirty="0">
                <a:ea typeface="+mn-lt"/>
                <a:cs typeface="+mn-lt"/>
              </a:rPr>
              <a:t>Uses continuous verb -</a:t>
            </a:r>
            <a:r>
              <a:rPr lang="en-US" sz="1000" dirty="0" err="1">
                <a:ea typeface="+mn-lt"/>
                <a:cs typeface="+mn-lt"/>
              </a:rPr>
              <a:t>ing</a:t>
            </a:r>
            <a:endParaRPr lang="en-US" sz="1000" dirty="0">
              <a:ea typeface="+mn-lt"/>
              <a:cs typeface="+mn-lt"/>
            </a:endParaRPr>
          </a:p>
          <a:p>
            <a:pPr marL="171450" indent="-171450">
              <a:buFont typeface="Arial,Sans-Serif"/>
              <a:buChar char="•"/>
            </a:pPr>
            <a:r>
              <a:rPr lang="en-US" sz="1000" dirty="0">
                <a:ea typeface="+mn-lt"/>
                <a:cs typeface="+mn-lt"/>
              </a:rPr>
              <a:t>Plural</a:t>
            </a:r>
          </a:p>
          <a:p>
            <a:pPr marL="171450" indent="-171450">
              <a:buFont typeface="Arial,Sans-Serif"/>
              <a:buChar char="•"/>
            </a:pPr>
            <a:r>
              <a:rPr lang="en-US" sz="1000" dirty="0">
                <a:ea typeface="+mn-lt"/>
                <a:cs typeface="+mn-lt"/>
              </a:rPr>
              <a:t>Avoids chained activities or choices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876974-6053-1EDB-9481-E3AEE7DF3C2B}"/>
              </a:ext>
            </a:extLst>
          </p:cNvPr>
          <p:cNvSpPr txBox="1"/>
          <p:nvPr/>
        </p:nvSpPr>
        <p:spPr>
          <a:xfrm>
            <a:off x="104288" y="3198247"/>
            <a:ext cx="3297360" cy="163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b="1" dirty="0"/>
              <a:t>Recommended approaches to content-validate EPAs </a:t>
            </a:r>
            <a:br>
              <a:rPr lang="en-AU" sz="1000" b="1" dirty="0"/>
            </a:br>
            <a:r>
              <a:rPr lang="en-AU" sz="1000" b="1" dirty="0"/>
              <a:t>(ten Cate et al, 2015) (21)</a:t>
            </a:r>
          </a:p>
          <a:p>
            <a:pPr algn="ctr"/>
            <a:endParaRPr lang="en-AU" sz="1000" b="1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cs typeface="Calibri"/>
              </a:rPr>
              <a:t>Matrix-map to competency frameworks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Expert meetings 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Surveys and interviews among experts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Delphi procedure*</a:t>
            </a:r>
          </a:p>
          <a:p>
            <a:pPr marL="171450" indent="-171450">
              <a:buFont typeface="Arial"/>
              <a:buChar char="•"/>
            </a:pPr>
            <a:r>
              <a:rPr lang="en-US" sz="1000" dirty="0">
                <a:cs typeface="Calibri"/>
              </a:rPr>
              <a:t>Nominal group technique</a:t>
            </a:r>
          </a:p>
          <a:p>
            <a:r>
              <a:rPr lang="en-US" sz="1000" dirty="0">
                <a:cs typeface="Calibri"/>
              </a:rPr>
              <a:t>* EPAs that are "flawed" in definition are difficult to correct and validat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ADBD70-F23B-B1ED-8258-3CC86B56C21C}"/>
              </a:ext>
            </a:extLst>
          </p:cNvPr>
          <p:cNvSpPr txBox="1"/>
          <p:nvPr/>
        </p:nvSpPr>
        <p:spPr>
          <a:xfrm>
            <a:off x="8698631" y="2183862"/>
            <a:ext cx="3385965" cy="27084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b="1" dirty="0"/>
              <a:t>Recommendations for diligent EPA Construct and Reporting in post-licensure healthcare</a:t>
            </a:r>
            <a:endParaRPr lang="en-AU" sz="1000" b="1" dirty="0">
              <a:solidFill>
                <a:srgbClr val="000000"/>
              </a:solidFill>
              <a:latin typeface="Calibri"/>
              <a:cs typeface="Calibri"/>
            </a:endParaRPr>
          </a:p>
          <a:p>
            <a:endParaRPr lang="en-US" sz="1000" u="sng" dirty="0">
              <a:latin typeface="Calibri"/>
              <a:cs typeface="Calibri"/>
            </a:endParaRPr>
          </a:p>
          <a:p>
            <a:r>
              <a:rPr lang="en-US" sz="1000" dirty="0">
                <a:ea typeface="+mn-lt"/>
                <a:cs typeface="+mn-lt"/>
              </a:rPr>
              <a:t>To promote EPA fidelity, quality appraisal and reduce subjectivity in consumer interpretation, we assert the proportional value of the following recommendations towards reporting EPA features and attributes:</a:t>
            </a:r>
            <a:endParaRPr lang="en-US" dirty="0"/>
          </a:p>
          <a:p>
            <a:endParaRPr lang="en-US" sz="1000" u="sng" dirty="0">
              <a:latin typeface="Calibri"/>
              <a:cs typeface="Calibri"/>
            </a:endParaRPr>
          </a:p>
          <a:p>
            <a:r>
              <a:rPr lang="en-US" sz="1000" dirty="0">
                <a:ea typeface="+mn-lt"/>
                <a:cs typeface="+mn-lt"/>
              </a:rPr>
              <a:t>1. Diligently reporting EPAs with their attributes and features, </a:t>
            </a:r>
            <a:r>
              <a:rPr lang="en-US" sz="1000">
                <a:ea typeface="+mn-lt"/>
                <a:cs typeface="+mn-lt"/>
              </a:rPr>
              <a:t>or directly citing towards the full specifications.</a:t>
            </a:r>
            <a:endParaRPr lang="en-US"/>
          </a:p>
          <a:p>
            <a:endParaRPr lang="en-US" sz="1000" dirty="0">
              <a:cs typeface="Calibri"/>
            </a:endParaRPr>
          </a:p>
          <a:p>
            <a:r>
              <a:rPr lang="en-US" sz="1000">
                <a:ea typeface="+mn-lt"/>
                <a:cs typeface="+mn-lt"/>
              </a:rPr>
              <a:t>2. Including reference to EPA design and content-validity </a:t>
            </a:r>
            <a:r>
              <a:rPr lang="en-US" sz="1000" dirty="0">
                <a:ea typeface="+mn-lt"/>
                <a:cs typeface="+mn-lt"/>
              </a:rPr>
              <a:t>information.</a:t>
            </a:r>
            <a:endParaRPr lang="en-US" dirty="0"/>
          </a:p>
          <a:p>
            <a:pPr marL="171450" indent="-171450">
              <a:buFont typeface="Arial"/>
              <a:buChar char="•"/>
            </a:pPr>
            <a:endParaRPr lang="en-US" sz="1000" dirty="0">
              <a:cs typeface="Calibri"/>
            </a:endParaRPr>
          </a:p>
          <a:p>
            <a:r>
              <a:rPr lang="en-US" sz="1000">
                <a:ea typeface="+mn-lt"/>
                <a:cs typeface="+mn-lt"/>
              </a:rPr>
              <a:t>3. Considering distinguishing the EPA as profession-specific or </a:t>
            </a:r>
            <a:r>
              <a:rPr lang="en-US" sz="1000" dirty="0">
                <a:ea typeface="+mn-lt"/>
                <a:cs typeface="+mn-lt"/>
              </a:rPr>
              <a:t>trans-discipline </a:t>
            </a:r>
            <a:endParaRPr lang="en-US"/>
          </a:p>
          <a:p>
            <a:endParaRPr lang="en-US" sz="1000" u="sng" dirty="0">
              <a:cs typeface="Calibri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52D4FF-CCDB-12DF-1E74-45DA6C3C6F94}"/>
              </a:ext>
            </a:extLst>
          </p:cNvPr>
          <p:cNvSpPr txBox="1"/>
          <p:nvPr/>
        </p:nvSpPr>
        <p:spPr>
          <a:xfrm>
            <a:off x="42403" y="28774"/>
            <a:ext cx="12012232" cy="2616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AU" sz="1100" b="1" dirty="0"/>
              <a:t>Supplementary File 1. Recommendations for EPA construct and reporting: towards fidelity and application to education and practice. Abbreviations: EPA, </a:t>
            </a:r>
            <a:r>
              <a:rPr lang="en-AU" sz="1100" b="1" dirty="0" err="1"/>
              <a:t>Entrustable</a:t>
            </a:r>
            <a:r>
              <a:rPr lang="en-AU" sz="1100" b="1" dirty="0"/>
              <a:t> Professional Activity</a:t>
            </a:r>
          </a:p>
        </p:txBody>
      </p:sp>
      <p:sp>
        <p:nvSpPr>
          <p:cNvPr id="15" name="Arrow: Chevron 14">
            <a:extLst>
              <a:ext uri="{FF2B5EF4-FFF2-40B4-BE49-F238E27FC236}">
                <a16:creationId xmlns:a16="http://schemas.microsoft.com/office/drawing/2014/main" id="{1E969800-1B3A-B730-8D25-9836E8138A9B}"/>
              </a:ext>
            </a:extLst>
          </p:cNvPr>
          <p:cNvSpPr/>
          <p:nvPr/>
        </p:nvSpPr>
        <p:spPr>
          <a:xfrm>
            <a:off x="61154" y="451015"/>
            <a:ext cx="11864162" cy="318976"/>
          </a:xfrm>
          <a:prstGeom prst="chevron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AU" b="1" dirty="0">
                <a:ea typeface="+mn-lt"/>
                <a:cs typeface="+mn-lt"/>
              </a:rPr>
              <a:t>Iterative evolution of EPA recommendations</a:t>
            </a:r>
            <a:endParaRPr lang="en-US" dirty="0"/>
          </a:p>
        </p:txBody>
      </p:sp>
      <p:sp>
        <p:nvSpPr>
          <p:cNvPr id="3" name="Arrow: Chevron 2">
            <a:extLst>
              <a:ext uri="{FF2B5EF4-FFF2-40B4-BE49-F238E27FC236}">
                <a16:creationId xmlns:a16="http://schemas.microsoft.com/office/drawing/2014/main" id="{C15C7F19-2163-4839-0F59-4B6F2F2CA5AA}"/>
              </a:ext>
            </a:extLst>
          </p:cNvPr>
          <p:cNvSpPr/>
          <p:nvPr/>
        </p:nvSpPr>
        <p:spPr>
          <a:xfrm>
            <a:off x="3382913" y="3195544"/>
            <a:ext cx="680955" cy="1632097"/>
          </a:xfrm>
          <a:prstGeom prst="chevron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7" name="Arrow: Chevron 16">
            <a:extLst>
              <a:ext uri="{FF2B5EF4-FFF2-40B4-BE49-F238E27FC236}">
                <a16:creationId xmlns:a16="http://schemas.microsoft.com/office/drawing/2014/main" id="{F728A211-AFC1-DB54-69AD-EEF31A404FF4}"/>
              </a:ext>
            </a:extLst>
          </p:cNvPr>
          <p:cNvSpPr/>
          <p:nvPr/>
        </p:nvSpPr>
        <p:spPr>
          <a:xfrm>
            <a:off x="7927524" y="891085"/>
            <a:ext cx="746002" cy="5886300"/>
          </a:xfrm>
          <a:prstGeom prst="chevron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83E00A4-4F5B-956A-653D-C75DDB481053}"/>
              </a:ext>
            </a:extLst>
          </p:cNvPr>
          <p:cNvGrpSpPr/>
          <p:nvPr/>
        </p:nvGrpSpPr>
        <p:grpSpPr>
          <a:xfrm>
            <a:off x="1492962" y="4969348"/>
            <a:ext cx="1904999" cy="1196161"/>
            <a:chOff x="1422078" y="4346280"/>
            <a:chExt cx="1904999" cy="1196161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C5B67D9-22E6-A631-B6B6-7BDE18D7A2E4}"/>
                </a:ext>
              </a:extLst>
            </p:cNvPr>
            <p:cNvSpPr txBox="1"/>
            <p:nvPr/>
          </p:nvSpPr>
          <p:spPr>
            <a:xfrm>
              <a:off x="1790072" y="4479620"/>
              <a:ext cx="1170510" cy="86177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AU" sz="1000" dirty="0"/>
                <a:t>Problem: EPA concept inconsistencies and dilution across contexts</a:t>
              </a:r>
              <a:endParaRPr lang="en-US" dirty="0"/>
            </a:p>
          </p:txBody>
        </p:sp>
        <p:sp>
          <p:nvSpPr>
            <p:cNvPr id="11" name="Parallelogram 10">
              <a:extLst>
                <a:ext uri="{FF2B5EF4-FFF2-40B4-BE49-F238E27FC236}">
                  <a16:creationId xmlns:a16="http://schemas.microsoft.com/office/drawing/2014/main" id="{ACAA75A3-0EA3-C803-44F8-6E85F530DC15}"/>
                </a:ext>
              </a:extLst>
            </p:cNvPr>
            <p:cNvSpPr/>
            <p:nvPr/>
          </p:nvSpPr>
          <p:spPr>
            <a:xfrm>
              <a:off x="1422078" y="4346280"/>
              <a:ext cx="1904999" cy="1196161"/>
            </a:xfrm>
            <a:prstGeom prst="parallelogram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A1F1A385-5D66-B0AE-DF5C-BE93AF6BAAC7}"/>
              </a:ext>
            </a:extLst>
          </p:cNvPr>
          <p:cNvGrpSpPr/>
          <p:nvPr/>
        </p:nvGrpSpPr>
        <p:grpSpPr>
          <a:xfrm>
            <a:off x="8723102" y="1014745"/>
            <a:ext cx="3331533" cy="531627"/>
            <a:chOff x="1422078" y="4346280"/>
            <a:chExt cx="1904999" cy="1196161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A5469F8-5714-DED6-D561-F113FED47F73}"/>
                </a:ext>
              </a:extLst>
            </p:cNvPr>
            <p:cNvSpPr txBox="1"/>
            <p:nvPr/>
          </p:nvSpPr>
          <p:spPr>
            <a:xfrm>
              <a:off x="1790072" y="4460384"/>
              <a:ext cx="1170510" cy="9002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91440" tIns="45720" rIns="91440" bIns="45720" rtlCol="0" anchor="ctr">
              <a:spAutoFit/>
            </a:bodyPr>
            <a:lstStyle/>
            <a:p>
              <a:pPr algn="ctr"/>
              <a:r>
                <a:rPr lang="en-AU" sz="1000" dirty="0"/>
                <a:t>Problem: EPAs variably constructed &amp; reported across contexts</a:t>
              </a:r>
              <a:endParaRPr lang="en-US" dirty="0"/>
            </a:p>
          </p:txBody>
        </p:sp>
        <p:sp>
          <p:nvSpPr>
            <p:cNvPr id="29" name="Parallelogram 28">
              <a:extLst>
                <a:ext uri="{FF2B5EF4-FFF2-40B4-BE49-F238E27FC236}">
                  <a16:creationId xmlns:a16="http://schemas.microsoft.com/office/drawing/2014/main" id="{C70D94EE-43F7-3891-37FD-3667A4152C46}"/>
                </a:ext>
              </a:extLst>
            </p:cNvPr>
            <p:cNvSpPr/>
            <p:nvPr/>
          </p:nvSpPr>
          <p:spPr>
            <a:xfrm>
              <a:off x="1422078" y="4346280"/>
              <a:ext cx="1904999" cy="1196161"/>
            </a:xfrm>
            <a:prstGeom prst="parallelogram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Arrow: Chevron 30">
            <a:extLst>
              <a:ext uri="{FF2B5EF4-FFF2-40B4-BE49-F238E27FC236}">
                <a16:creationId xmlns:a16="http://schemas.microsoft.com/office/drawing/2014/main" id="{318006BD-AC7E-8A30-01F6-8A4B5C40D4C8}"/>
              </a:ext>
            </a:extLst>
          </p:cNvPr>
          <p:cNvSpPr/>
          <p:nvPr/>
        </p:nvSpPr>
        <p:spPr>
          <a:xfrm>
            <a:off x="3399333" y="989287"/>
            <a:ext cx="670795" cy="2042041"/>
          </a:xfrm>
          <a:prstGeom prst="chevron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2" name="Arrow: Chevron 31">
            <a:extLst>
              <a:ext uri="{FF2B5EF4-FFF2-40B4-BE49-F238E27FC236}">
                <a16:creationId xmlns:a16="http://schemas.microsoft.com/office/drawing/2014/main" id="{3E42A187-F453-2024-C551-903F7FCC7218}"/>
              </a:ext>
            </a:extLst>
          </p:cNvPr>
          <p:cNvSpPr/>
          <p:nvPr/>
        </p:nvSpPr>
        <p:spPr>
          <a:xfrm>
            <a:off x="3399334" y="4969604"/>
            <a:ext cx="681823" cy="1186871"/>
          </a:xfrm>
          <a:prstGeom prst="chevron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1054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75E813B1BC29147B3DAE0AA5E4A36F1" ma:contentTypeVersion="6" ma:contentTypeDescription="Create a new document." ma:contentTypeScope="" ma:versionID="044a2e7033eeae6a4ea47e040bdbbaaa">
  <xsd:schema xmlns:xsd="http://www.w3.org/2001/XMLSchema" xmlns:xs="http://www.w3.org/2001/XMLSchema" xmlns:p="http://schemas.microsoft.com/office/2006/metadata/properties" xmlns:ns2="e2bf8928-48d7-460a-8920-8e3880a7f6b6" xmlns:ns3="af801209-01be-4866-84d5-6454cfc83124" targetNamespace="http://schemas.microsoft.com/office/2006/metadata/properties" ma:root="true" ma:fieldsID="49c6d2ce69f76e9ef99fc21e67902b28" ns2:_="" ns3:_="">
    <xsd:import namespace="e2bf8928-48d7-460a-8920-8e3880a7f6b6"/>
    <xsd:import namespace="af801209-01be-4866-84d5-6454cfc8312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bf8928-48d7-460a-8920-8e3880a7f6b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f801209-01be-4866-84d5-6454cfc83124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F71BCE0-9EC6-4EC3-85FC-AE9AA6B7E7A4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5A296E72-0F8D-47A8-86FF-D66E6F06B19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B142A6D-C483-4D8A-9280-4259524BC6B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2bf8928-48d7-460a-8920-8e3880a7f6b6"/>
    <ds:schemaRef ds:uri="af801209-01be-4866-84d5-6454cfc8312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513</Words>
  <Application>Microsoft Office PowerPoint</Application>
  <PresentationFormat>Widescreen</PresentationFormat>
  <Paragraphs>6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Arial,Sans-Serif</vt:lpstr>
      <vt:lpstr>Calibri</vt:lpstr>
      <vt:lpstr>Calibri Light</vt:lpstr>
      <vt:lpstr>Times New Roman</vt:lpstr>
      <vt:lpstr>office them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Round 2</cp:lastModifiedBy>
  <cp:revision>278</cp:revision>
  <dcterms:created xsi:type="dcterms:W3CDTF">2022-06-17T08:22:49Z</dcterms:created>
  <dcterms:modified xsi:type="dcterms:W3CDTF">2023-05-10T11:54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75E813B1BC29147B3DAE0AA5E4A36F1</vt:lpwstr>
  </property>
</Properties>
</file>